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0" r:id="rId2"/>
    <p:sldId id="271" r:id="rId3"/>
  </p:sldIdLst>
  <p:sldSz cx="12192000" cy="6858000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1/7/2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596348" y="2551837"/>
            <a:ext cx="105354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. Phylogenetic tree analysis of Global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A-175 region II.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bank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 number of each </a:t>
            </a:r>
            <a:r>
              <a:rPr lang="en-US" altLang="zh-CN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BA-175 region II is shown with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each sample.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1636121-16A2-4573-80AD-6F2CFBE3A16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0"/>
            <a:ext cx="1088435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29634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27</Words>
  <Application>Microsoft Office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卢敏丽</dc:creator>
  <cp:lastModifiedBy>杨培奎</cp:lastModifiedBy>
  <cp:revision>34</cp:revision>
  <cp:lastPrinted>2021-03-03T05:37:08Z</cp:lastPrinted>
  <dcterms:created xsi:type="dcterms:W3CDTF">2021-01-18T15:03:00Z</dcterms:created>
  <dcterms:modified xsi:type="dcterms:W3CDTF">2021-07-28T05:14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